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/>
    <p:restoredTop sz="82690"/>
  </p:normalViewPr>
  <p:slideViewPr>
    <p:cSldViewPr snapToGrid="0">
      <p:cViewPr varScale="1">
        <p:scale>
          <a:sx n="84" d="100"/>
          <a:sy n="84" d="100"/>
        </p:scale>
        <p:origin x="130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BCEBF8-1FAD-C94E-8B70-42B2304BAEBE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5E238-8B3C-C84F-B771-BCE46D6E6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62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85E238-8B3C-C84F-B771-BCE46D6E613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125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864EF-0380-022C-49E6-F4B53E6FF7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2AEF9B-F64B-6F25-130D-FF1DE5F342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2EC634-6345-4AB4-6976-A4B44E6D0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B2296-85D8-8DD6-92AF-279C7E212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54D77-34B2-8860-E69E-73DD52B0A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09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38FCD-8CDB-AF01-60BF-C3B77C4B8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211CBD-462C-D068-6857-F6D9A19416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217A9-C665-8AB1-6447-C7C121712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68A070-A62F-60F5-5708-F1DF14625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BB1377-E87F-5C88-D2B2-2E86687A4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65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2114A0-D950-E751-2B38-1AC371C4B1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5C1461-D7FF-4B74-653B-5E639D4400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A27EAB-2562-1C5F-9C15-A75AFCE98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6C78C-0195-17A1-0428-7F29871E2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85B981-C27C-C10D-FD93-4BFB7F636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950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36C11-6400-6ADF-E88A-F78661F4A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2D0AEF-2D3C-A7EC-AB2D-0E1E2CDD14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1E03C-704A-C41F-E9B8-196AB7701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373AEF-7A1C-31EA-21A9-B8BBAAF6E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7EAA63-C4AC-E03B-FCEC-0B87AF6F7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913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32E684-DA87-D274-9D93-BDEE243D26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064931-3F94-E2D8-50AF-EE7885F9E2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837DA-61EB-096B-88CD-3C2C92340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9A9E2-86F8-04E7-A4D4-58304E81F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7AACE5-B66F-2E63-7570-1DD073640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388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0FF87-C8E2-BA52-B5C5-8BC013AE0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6BE06D-0737-E775-5929-F452E22E96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F84239-6E36-4FB5-7210-3377615A24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105205-B4DD-81FE-962D-D382FC977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2075AB-070D-C793-901F-7544D492D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6D11CD-742E-84F8-9CBA-E294DC7E3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329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9BA-126C-3A93-4747-1ED2ED4472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A90AB7-AA76-EC8E-3161-9359594992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5FDE2E-AEB0-D56F-54CC-FE33090641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D54D2A-C078-B8DF-70C0-232CC5D993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C6BA82-90C5-8FF4-88C8-B42A90431D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C8593D-E1DE-CEBD-14D0-782B25B34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3885EF-767E-AF07-E5C6-24AB85A60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FBCEC0-204B-E9E3-2051-E63C58F62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70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13E62-A6BD-7131-6BCA-0B663736C7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AD67178-9B3A-A6A3-966D-ED8FB3CCE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FF02F8-9BB7-DD78-BC6D-FD6FF8E55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49F863-651A-32EA-BAA3-82DF2B165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060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C26098-171D-E123-4111-4C10D58DC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4A68A3-A975-1CC1-A711-CF9DADF24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1F728A-B1EA-A766-85C3-1D4A84020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477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71C249-6DAF-8BA5-35BE-45A0D7207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2DA966-EAD6-38DE-927E-2F3B96AB2A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646F72-8E44-45EB-2142-D6385167C9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CC4F34-34C0-CAFE-7FDF-00DFBAEBB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3FC7EA-A363-FA6D-E75A-ADC0F83B1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BC34CE-0E7E-8249-3FBA-8FCB9EE7C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883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92956-93F6-908D-FDA3-5FC36BB0A0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D341AD-D796-5B49-47CA-A13013AE55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3E2BAF-E252-B817-A737-1C29E3A225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62B00C-4F39-9399-EDEF-DB77B4F53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44CE17-CC5D-FDB9-16D3-79C7ED9E9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3088DF-16CE-620A-2638-6FC0FFC70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890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7318BE-C920-7FDD-DCAB-95EBE20EF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32336-0E94-522A-5940-11ABF2B5B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145C99-3CAA-9751-3D11-5263CA146C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0BBA77-A629-344C-84D4-50B24E9B251F}" type="datetimeFigureOut">
              <a:rPr lang="en-US" smtClean="0"/>
              <a:t>3/9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29160-60B4-5F08-1A30-CE68360239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5FEEE5-0516-6294-F58F-D2D6857D14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A5F8A9-B6ED-C44E-ACFE-84DEFA3C8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030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chemical formulas&#10;&#10;AI-generated content may be incorrect.">
            <a:extLst>
              <a:ext uri="{FF2B5EF4-FFF2-40B4-BE49-F238E27FC236}">
                <a16:creationId xmlns:a16="http://schemas.microsoft.com/office/drawing/2014/main" id="{E7E52094-D002-5598-F236-59B2F36F2AC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10" t="3548" r="6906" b="3971"/>
          <a:stretch>
            <a:fillRect/>
          </a:stretch>
        </p:blipFill>
        <p:spPr>
          <a:xfrm>
            <a:off x="1083335" y="744451"/>
            <a:ext cx="10025327" cy="46841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B1350CA-9058-951C-65D6-D96A7309164D}"/>
              </a:ext>
            </a:extLst>
          </p:cNvPr>
          <p:cNvSpPr txBox="1"/>
          <p:nvPr/>
        </p:nvSpPr>
        <p:spPr>
          <a:xfrm>
            <a:off x="1470672" y="5582231"/>
            <a:ext cx="925065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4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l Figure 1. MS fragmentation for </a:t>
            </a:r>
            <a:r>
              <a:rPr lang="en-CA" sz="14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feature </a:t>
            </a:r>
            <a:r>
              <a:rPr lang="en-CA" sz="14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utatively identified as N-Caffeoyl putrescine.</a:t>
            </a:r>
          </a:p>
          <a:p>
            <a:r>
              <a:rPr lang="en-CA" sz="14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High-resolution mass spectrum of in-source fragments of peaks at 2.63 minutes (2.63_251.1391m/z). The two fragments correspond to the loss of the terminal amine (m/z 234.1129) and the loss of putrescine (m/z 163.0395). </a:t>
            </a:r>
          </a:p>
        </p:txBody>
      </p:sp>
    </p:spTree>
    <p:extLst>
      <p:ext uri="{BB962C8B-B14F-4D97-AF65-F5344CB8AC3E}">
        <p14:creationId xmlns:p14="http://schemas.microsoft.com/office/powerpoint/2010/main" val="4202841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types of numbers&#10;&#10;AI-generated content may be incorrect.">
            <a:extLst>
              <a:ext uri="{FF2B5EF4-FFF2-40B4-BE49-F238E27FC236}">
                <a16:creationId xmlns:a16="http://schemas.microsoft.com/office/drawing/2014/main" id="{91111B50-F8F4-CC2F-8DAC-646EB36088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3966" y="321937"/>
            <a:ext cx="11464067" cy="50576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BD894C7-9754-C64C-58E5-A5D0E3BE9BC5}"/>
              </a:ext>
            </a:extLst>
          </p:cNvPr>
          <p:cNvSpPr txBox="1"/>
          <p:nvPr/>
        </p:nvSpPr>
        <p:spPr>
          <a:xfrm>
            <a:off x="1581509" y="5379614"/>
            <a:ext cx="925065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4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l Figure 2. MS Chromatogram and quantification of FP and CP isomers </a:t>
            </a:r>
          </a:p>
          <a:p>
            <a:r>
              <a:rPr lang="en-CA" sz="14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)</a:t>
            </a:r>
            <a:r>
              <a:rPr lang="en-CA" sz="14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Representative chromatogram from a VFb49 sample showing FP and CP isomers intensities plotted on the same relative intensity scale.  </a:t>
            </a:r>
            <a:r>
              <a:rPr lang="en-CA" sz="14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) </a:t>
            </a:r>
            <a:r>
              <a:rPr lang="en-CA" sz="14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Quantification of their corresponding normalized abundances </a:t>
            </a:r>
            <a:r>
              <a:rPr lang="en-CA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400" dirty="0">
                <a:cs typeface="Arial" panose="020B0604020202020204" pitchFamily="34" charset="0"/>
              </a:rPr>
              <a:t>Each bar represents the mean ± SE</a:t>
            </a:r>
            <a:r>
              <a:rPr lang="en-US" sz="1400" kern="100" dirty="0">
                <a:cs typeface="Times New Roman" panose="02020603050405020304" pitchFamily="18" charset="0"/>
              </a:rPr>
              <a:t>, </a:t>
            </a:r>
            <a:r>
              <a:rPr lang="en-US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= 3;  </a:t>
            </a:r>
            <a:r>
              <a:rPr lang="en-CA" sz="1400" kern="10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*** p &lt; 0.001, ** p &lt; 0.01, * p &lt; </a:t>
            </a:r>
            <a:r>
              <a:rPr lang="en-CA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0.05 . ANOVA followed by post hoc Dunnett’s test was used to assess significant against MgSO</a:t>
            </a:r>
            <a:r>
              <a:rPr lang="en-CA" sz="1400" kern="100" baseline="-25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  </a:t>
            </a:r>
            <a:r>
              <a:rPr lang="en-CA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reated samples. FDR correction was used to correct for multiple comparisons).</a:t>
            </a:r>
            <a:r>
              <a:rPr lang="en-CA" sz="1400" b="1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CA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 – MgSO</a:t>
            </a:r>
            <a:r>
              <a:rPr lang="en-CA" sz="1400" kern="100" baseline="-250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en-CA" sz="1400" kern="100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CA" sz="1400" dirty="0"/>
              <a:t>E – </a:t>
            </a:r>
            <a:r>
              <a:rPr lang="en-CA" sz="1400" i="1" dirty="0"/>
              <a:t>E. coli</a:t>
            </a:r>
            <a:r>
              <a:rPr lang="en-CA" sz="1400" dirty="0"/>
              <a:t>, V – VFb49, W – WCS374r. </a:t>
            </a:r>
            <a:endParaRPr lang="en-CA" sz="1400" kern="100" dirty="0"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6532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</TotalTime>
  <Words>176</Words>
  <Application>Microsoft Office PowerPoint</Application>
  <PresentationFormat>Widescreen</PresentationFormat>
  <Paragraphs>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ckenzie Loranger</dc:creator>
  <cp:lastModifiedBy>Keiko Yoshioka</cp:lastModifiedBy>
  <cp:revision>8</cp:revision>
  <dcterms:created xsi:type="dcterms:W3CDTF">2026-01-05T05:05:53Z</dcterms:created>
  <dcterms:modified xsi:type="dcterms:W3CDTF">2026-03-09T18:43:27Z</dcterms:modified>
</cp:coreProperties>
</file>